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4114800" cy="36576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DF0B86-528C-40A9-A1AF-000250FAC5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06280" y="147240"/>
            <a:ext cx="3702240" cy="6094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06280" y="853560"/>
            <a:ext cx="370224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06280" y="2114280"/>
            <a:ext cx="370224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CE1D6-A6CE-40C0-B7AB-A19407E59B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06280" y="147240"/>
            <a:ext cx="3702240" cy="6094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06280" y="853560"/>
            <a:ext cx="180648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103480" y="853560"/>
            <a:ext cx="180648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06280" y="2114280"/>
            <a:ext cx="180648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103480" y="2114280"/>
            <a:ext cx="180648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78E011-DC0A-4EED-9F35-B0BB5BA393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06280" y="147240"/>
            <a:ext cx="3702240" cy="6094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06280" y="853560"/>
            <a:ext cx="119196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458360" y="853560"/>
            <a:ext cx="119196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710080" y="853560"/>
            <a:ext cx="119196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06280" y="2114280"/>
            <a:ext cx="119196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458360" y="2114280"/>
            <a:ext cx="119196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710080" y="2114280"/>
            <a:ext cx="119196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5A5AE-B2B7-444D-824A-7FB986D70D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06280" y="147240"/>
            <a:ext cx="3702240" cy="6094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06280" y="853560"/>
            <a:ext cx="3702240" cy="241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00"/>
              </a:spcBef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82BD31-7EB4-491D-B503-1DBF8F5BD2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06280" y="147240"/>
            <a:ext cx="3702240" cy="6094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06280" y="853560"/>
            <a:ext cx="3702240" cy="24130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B3C35-BE4C-40DF-A1C2-DECF65EB24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06280" y="147240"/>
            <a:ext cx="3702240" cy="6094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06280" y="853560"/>
            <a:ext cx="1806480" cy="24130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103480" y="853560"/>
            <a:ext cx="1806480" cy="24130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71F73B-5E2E-49A3-9E70-E9E4E3DC94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06280" y="147240"/>
            <a:ext cx="3702240" cy="6094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EDC0BC-6E73-43B2-BA88-5CB2EA5C89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06280" y="147240"/>
            <a:ext cx="3702240" cy="282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00"/>
              </a:spcBef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C85BF0-DC32-47D8-9224-2B9048852B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06280" y="147240"/>
            <a:ext cx="3702240" cy="6094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06280" y="853560"/>
            <a:ext cx="180648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103480" y="853560"/>
            <a:ext cx="1806480" cy="24130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06280" y="2114280"/>
            <a:ext cx="180648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59584-1F6C-4FE0-863D-3E9D9AAE1D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06280" y="147240"/>
            <a:ext cx="3702240" cy="6094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06280" y="853560"/>
            <a:ext cx="1806480" cy="24130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103480" y="853560"/>
            <a:ext cx="180648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103480" y="2114280"/>
            <a:ext cx="180648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CDD6F2-F254-4926-9BE0-251347F8DF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06280" y="147240"/>
            <a:ext cx="3702240" cy="6094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06280" y="853560"/>
            <a:ext cx="180648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103480" y="853560"/>
            <a:ext cx="180648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06280" y="2114280"/>
            <a:ext cx="3702240" cy="115092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indent="0">
              <a:spcBef>
                <a:spcPts val="400"/>
              </a:spcBef>
              <a:buNone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8083A-2D92-4995-811F-788678A31C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06280" y="147240"/>
            <a:ext cx="3702240" cy="6094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ctr">
            <a:noAutofit/>
          </a:bodyPr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06280" y="853560"/>
            <a:ext cx="3702240" cy="241308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rmAutofit/>
          </a:bodyPr>
          <a:p>
            <a:pPr marL="166680" indent="-16668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1" marL="360360" indent="-1382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2" marL="555480" indent="-11268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3" marL="777960" indent="-1112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4" marL="998640" indent="-10980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5" marL="998640" indent="-10980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lvl="6" marL="998640" indent="-109800">
              <a:spcBef>
                <a:spcPts val="400"/>
              </a:spcBef>
              <a:buClr>
                <a:srgbClr val="000000"/>
              </a:buClr>
              <a:buFont typeface="Arial"/>
              <a:buChar char="»"/>
              <a:tabLst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06280" y="3330360"/>
            <a:ext cx="959040" cy="25380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Autofit/>
          </a:bodyPr>
          <a:lstStyle>
            <a:lvl1pPr indent="0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  <a:defRPr b="0" lang="en-US" sz="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405080" y="3330360"/>
            <a:ext cx="1304640" cy="25380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Autofit/>
          </a:bodyPr>
          <a:lstStyle>
            <a:lvl1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  <a:defRPr b="0" lang="en-US" sz="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949480" y="3330360"/>
            <a:ext cx="959040" cy="253800"/>
          </a:xfrm>
          <a:prstGeom prst="rect">
            <a:avLst/>
          </a:prstGeom>
          <a:noFill/>
          <a:ln w="0">
            <a:noFill/>
          </a:ln>
        </p:spPr>
        <p:txBody>
          <a:bodyPr lIns="44280" rIns="44280" tIns="22320" bIns="22320" anchor="t">
            <a:noAutofit/>
          </a:bodyPr>
          <a:lstStyle>
            <a:lvl1pPr indent="0" algn="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  <a:defRPr b="0" lang="en-US" sz="6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42800"/>
                <a:tab algn="l" pos="885960"/>
                <a:tab algn="l" pos="1328760"/>
                <a:tab algn="l" pos="1771560"/>
                <a:tab algn="l" pos="2214720"/>
                <a:tab algn="l" pos="2657520"/>
                <a:tab algn="l" pos="3100320"/>
                <a:tab algn="l" pos="3543480"/>
                <a:tab algn="l" pos="3986280"/>
                <a:tab algn="l" pos="4429080"/>
                <a:tab algn="l" pos="4871880"/>
                <a:tab algn="l" pos="5315040"/>
                <a:tab algn="l" pos="5757840"/>
                <a:tab algn="l" pos="6200640"/>
                <a:tab algn="l" pos="6643800"/>
                <a:tab algn="l" pos="7086600"/>
                <a:tab algn="l" pos="7529400"/>
                <a:tab algn="l" pos="7972560"/>
                <a:tab algn="l" pos="8415360"/>
                <a:tab algn="l" pos="8858160"/>
              </a:tabLst>
            </a:pPr>
            <a:fld id="{9A8FD1EC-1BC7-4064-8664-F80FDD902E6B}" type="slidenum">
              <a:rPr b="0" lang="en-US" sz="6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30978" t="47454" r="38104" b="10678"/>
          <a:stretch/>
        </p:blipFill>
        <p:spPr>
          <a:xfrm>
            <a:off x="833400" y="316080"/>
            <a:ext cx="1873440" cy="35287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809640" y="41400"/>
            <a:ext cx="81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A-Nc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544760" y="39600"/>
            <a:ext cx="81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A-Nck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906480" y="316080"/>
            <a:ext cx="64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625760" y="316080"/>
            <a:ext cx="647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-30240" y="234324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an-Nc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66680" y="3073320"/>
            <a:ext cx="4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634120" y="2125800"/>
            <a:ext cx="73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A-Nc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634120" y="2981160"/>
            <a:ext cx="73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A-Nc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635200" y="2352600"/>
            <a:ext cx="142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ndogenous Nc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1400" y="140976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ck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1400" y="60480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c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633760" y="1324080"/>
            <a:ext cx="81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A-Nck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633760" y="460440"/>
            <a:ext cx="81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A-Nc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635200" y="690480"/>
            <a:ext cx="142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ndogenous Nc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635200" y="1554120"/>
            <a:ext cx="142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ndogenous Nc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9T21:26:30Z</dcterms:created>
  <dc:creator>Louise Larose</dc:creator>
  <dc:description/>
  <dc:language>en-US</dc:language>
  <cp:lastModifiedBy>Dr. Louise Larose</cp:lastModifiedBy>
  <dcterms:modified xsi:type="dcterms:W3CDTF">2011-10-05T14:14:12Z</dcterms:modified>
  <cp:revision>12</cp:revision>
  <dc:subject/>
  <dc:title>Slide 1</dc:title>
</cp:coreProperties>
</file>